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0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532CE3A-62D3-B926-119B-2168D202314A}" name="Guarnerio,Jlenia" initials="" userId="S::JGuarnerio@mdanderson.org::dfb0fcd7-5eeb-4e07-a3e8-0dbf46734738" providerId="AD"/>
  <p188:author id="{FD3A1B70-C47D-2978-6E35-9644E6951293}" name="Fowler,Annaliese C" initials="AF" userId="S::ACFowler@mdanderson.org::f91aa872-49e4-4bbc-881e-a32f85655ddd" providerId="AD"/>
  <p188:author id="{C75D9BB2-3030-0BEA-2014-5164B48CAF98}" name="Ko,Emily Y" initials="EK" userId="S::EYKo@mdanderson.org::e85af6e4-4179-4a49-9099-726ab25fb60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B75"/>
    <a:srgbClr val="EFEDE0"/>
    <a:srgbClr val="D0F4DD"/>
    <a:srgbClr val="B5EBAF"/>
    <a:srgbClr val="FEEE8F"/>
    <a:srgbClr val="A3F4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DA00EFC-EDE7-6C4E-A43B-8186FA72040C}" v="2" dt="2025-11-07T15:16:53.5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7"/>
    <p:restoredTop sz="96098"/>
  </p:normalViewPr>
  <p:slideViewPr>
    <p:cSldViewPr snapToGrid="0">
      <p:cViewPr varScale="1">
        <p:scale>
          <a:sx n="86" d="100"/>
          <a:sy n="86" d="100"/>
        </p:scale>
        <p:origin x="29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uarnerio,Jlenia" userId="dfb0fcd7-5eeb-4e07-a3e8-0dbf46734738" providerId="ADAL" clId="{6BCDEB6B-0311-5B2F-9DCA-D1F02FE497D1}"/>
    <pc:docChg chg="modSld">
      <pc:chgData name="Guarnerio,Jlenia" userId="dfb0fcd7-5eeb-4e07-a3e8-0dbf46734738" providerId="ADAL" clId="{6BCDEB6B-0311-5B2F-9DCA-D1F02FE497D1}" dt="2025-11-07T15:16:57.434" v="4" actId="14100"/>
      <pc:docMkLst>
        <pc:docMk/>
      </pc:docMkLst>
      <pc:sldChg chg="addSp modSp mod">
        <pc:chgData name="Guarnerio,Jlenia" userId="dfb0fcd7-5eeb-4e07-a3e8-0dbf46734738" providerId="ADAL" clId="{6BCDEB6B-0311-5B2F-9DCA-D1F02FE497D1}" dt="2025-11-07T15:16:57.434" v="4" actId="14100"/>
        <pc:sldMkLst>
          <pc:docMk/>
          <pc:sldMk cId="636785219" sldId="403"/>
        </pc:sldMkLst>
        <pc:spChg chg="add mod">
          <ac:chgData name="Guarnerio,Jlenia" userId="dfb0fcd7-5eeb-4e07-a3e8-0dbf46734738" providerId="ADAL" clId="{6BCDEB6B-0311-5B2F-9DCA-D1F02FE497D1}" dt="2025-11-07T15:16:57.434" v="4" actId="14100"/>
          <ac:spMkLst>
            <pc:docMk/>
            <pc:sldMk cId="636785219" sldId="403"/>
            <ac:spMk id="8" creationId="{15BF38E1-4F07-C598-1006-A802FF564D99}"/>
          </ac:spMkLst>
        </pc:spChg>
      </pc:sldChg>
    </pc:docChg>
  </pc:docChgLst>
  <pc:docChgLst>
    <pc:chgData name="Guarnerio,Jlenia" userId="dfb0fcd7-5eeb-4e07-a3e8-0dbf46734738" providerId="ADAL" clId="{9FD58F3F-BFD8-5C05-9AE2-EBA86E84DD77}"/>
    <pc:docChg chg="custSel addSld delSld modSld">
      <pc:chgData name="Guarnerio,Jlenia" userId="dfb0fcd7-5eeb-4e07-a3e8-0dbf46734738" providerId="ADAL" clId="{9FD58F3F-BFD8-5C05-9AE2-EBA86E84DD77}" dt="2025-11-05T19:13:48.321" v="76" actId="2696"/>
      <pc:docMkLst>
        <pc:docMk/>
      </pc:docMkLst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3EC13-60F4-8940-B473-63C174F810F9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EDABD9-EFC5-244F-8ED7-0D9691070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875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419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158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9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512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372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121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91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09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961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135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198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794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97B9BA8-9541-21AA-05AB-46C2EBA277C6}"/>
              </a:ext>
            </a:extLst>
          </p:cNvPr>
          <p:cNvSpPr txBox="1"/>
          <p:nvPr/>
        </p:nvSpPr>
        <p:spPr>
          <a:xfrm>
            <a:off x="77771" y="0"/>
            <a:ext cx="6702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>
                <a:latin typeface="Helvetica" pitchFamily="2" charset="0"/>
              </a:rPr>
              <a:t>Figure S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05E136D-1E90-7C83-2788-DCC5E4E02C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179" y="510733"/>
            <a:ext cx="1274441" cy="205284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1FC6556-DB48-B98D-E3AB-0586E40402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0491" y="510733"/>
            <a:ext cx="1274441" cy="205284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D2E5F97-0129-2769-F09D-139D731713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97672" y="510733"/>
            <a:ext cx="1274441" cy="205284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38F18D2-7424-08FD-25DD-A886C47C29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15803" y="510733"/>
            <a:ext cx="1274441" cy="205284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5B9E233-EFA0-D178-2A95-D537869B86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03949" y="454912"/>
            <a:ext cx="1309096" cy="21086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5BF38E1-4F07-C598-1006-A802FF564D99}"/>
              </a:ext>
            </a:extLst>
          </p:cNvPr>
          <p:cNvSpPr txBox="1"/>
          <p:nvPr/>
        </p:nvSpPr>
        <p:spPr>
          <a:xfrm>
            <a:off x="265179" y="3267856"/>
            <a:ext cx="622506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4. </a:t>
            </a:r>
            <a:r>
              <a:rPr lang="en-US" dirty="0"/>
              <a:t>Differential expression of macrophage-related genes in BMDM vs BMDM cultured with recombinant POSTN (</a:t>
            </a:r>
            <a:r>
              <a:rPr lang="en-US" dirty="0" err="1"/>
              <a:t>rPOSTN</a:t>
            </a:r>
            <a:r>
              <a:rPr lang="en-US" dirty="0"/>
              <a:t>). No major differences were identified in this experimental setting. </a:t>
            </a:r>
          </a:p>
        </p:txBody>
      </p:sp>
    </p:spTree>
    <p:extLst>
      <p:ext uri="{BB962C8B-B14F-4D97-AF65-F5344CB8AC3E}">
        <p14:creationId xmlns:p14="http://schemas.microsoft.com/office/powerpoint/2010/main" val="636785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</TotalTime>
  <Words>32</Words>
  <Application>Microsoft Macintosh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arnerio, Jlenia</dc:creator>
  <cp:lastModifiedBy>Guarnerio,Jlenia</cp:lastModifiedBy>
  <cp:revision>1</cp:revision>
  <dcterms:created xsi:type="dcterms:W3CDTF">2021-05-16T05:20:50Z</dcterms:created>
  <dcterms:modified xsi:type="dcterms:W3CDTF">2025-11-07T15:16:58Z</dcterms:modified>
</cp:coreProperties>
</file>